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792" r:id="rId2"/>
    <p:sldId id="791" r:id="rId3"/>
  </p:sldIdLst>
  <p:sldSz cx="12192000" cy="6858000"/>
  <p:notesSz cx="7011988" cy="92979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03BD"/>
    <a:srgbClr val="E226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95" d="100"/>
          <a:sy n="95" d="100"/>
        </p:scale>
        <p:origin x="2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5" indent="0" algn="ctr">
              <a:buNone/>
              <a:defRPr sz="2000"/>
            </a:lvl2pPr>
            <a:lvl3pPr marL="914409" indent="0" algn="ctr">
              <a:buNone/>
              <a:defRPr sz="1800"/>
            </a:lvl3pPr>
            <a:lvl4pPr marL="1371614" indent="0" algn="ctr">
              <a:buNone/>
              <a:defRPr sz="1600"/>
            </a:lvl4pPr>
            <a:lvl5pPr marL="1828818" indent="0" algn="ctr">
              <a:buNone/>
              <a:defRPr sz="1600"/>
            </a:lvl5pPr>
            <a:lvl6pPr marL="2286023" indent="0" algn="ctr">
              <a:buNone/>
              <a:defRPr sz="1600"/>
            </a:lvl6pPr>
            <a:lvl7pPr marL="2743227" indent="0" algn="ctr">
              <a:buNone/>
              <a:defRPr sz="1600"/>
            </a:lvl7pPr>
            <a:lvl8pPr marL="3200432" indent="0" algn="ctr">
              <a:buNone/>
              <a:defRPr sz="1600"/>
            </a:lvl8pPr>
            <a:lvl9pPr marL="365763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66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218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156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AE7126-619C-4F60-B947-EE2A832CE45A}"/>
              </a:ext>
            </a:extLst>
          </p:cNvPr>
          <p:cNvSpPr txBox="1"/>
          <p:nvPr userDrawn="1"/>
        </p:nvSpPr>
        <p:spPr>
          <a:xfrm>
            <a:off x="1" y="88655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88FEC08-F4DB-407E-A6B9-A1027581052A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/>
          <a:stretch>
            <a:fillRect/>
          </a:stretch>
        </p:blipFill>
        <p:spPr>
          <a:xfrm>
            <a:off x="11321873" y="6207092"/>
            <a:ext cx="850465" cy="6378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7307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466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829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8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927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BEA79D-5C92-4E29-AE2E-3549BE526C0A}"/>
              </a:ext>
            </a:extLst>
          </p:cNvPr>
          <p:cNvSpPr txBox="1"/>
          <p:nvPr userDrawn="1"/>
        </p:nvSpPr>
        <p:spPr>
          <a:xfrm>
            <a:off x="1" y="85617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8081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0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578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5" indent="0">
              <a:buNone/>
              <a:defRPr sz="2800"/>
            </a:lvl2pPr>
            <a:lvl3pPr marL="914409" indent="0">
              <a:buNone/>
              <a:defRPr sz="2400"/>
            </a:lvl3pPr>
            <a:lvl4pPr marL="1371614" indent="0">
              <a:buNone/>
              <a:defRPr sz="2000"/>
            </a:lvl4pPr>
            <a:lvl5pPr marL="1828818" indent="0">
              <a:buNone/>
              <a:defRPr sz="2000"/>
            </a:lvl5pPr>
            <a:lvl6pPr marL="2286023" indent="0">
              <a:buNone/>
              <a:defRPr sz="2000"/>
            </a:lvl6pPr>
            <a:lvl7pPr marL="2743227" indent="0">
              <a:buNone/>
              <a:defRPr sz="2000"/>
            </a:lvl7pPr>
            <a:lvl8pPr marL="3200432" indent="0">
              <a:buNone/>
              <a:defRPr sz="2000"/>
            </a:lvl8pPr>
            <a:lvl9pPr marL="3657637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034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F032E-6009-4DF4-BC5D-A56E6D51A59A}" type="datetimeFigureOut">
              <a:rPr lang="en-IN" smtClean="0"/>
              <a:t>31-05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02573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9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2" indent="-228602" algn="l" defTabSz="914409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7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16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25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0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34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39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5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9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4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18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3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2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32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3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25EE2C35-555B-48AF-B878-D3B33BDD1DC4}"/>
              </a:ext>
            </a:extLst>
          </p:cNvPr>
          <p:cNvSpPr txBox="1"/>
          <p:nvPr/>
        </p:nvSpPr>
        <p:spPr>
          <a:xfrm>
            <a:off x="256820" y="51278"/>
            <a:ext cx="11678360" cy="10915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8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low Cytometry; Prostate cancer cell lines stained with stemness markers (CD44, CD133 and CD44/133) to determine the percent of CD44</a:t>
            </a:r>
            <a:r>
              <a:rPr lang="en-US" sz="11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D133</a:t>
            </a:r>
            <a:r>
              <a:rPr lang="en-US" sz="11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ouble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ositive cells among PCa subtypes. </a:t>
            </a:r>
            <a:endParaRPr lang="en-US" sz="11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eatments with CONV-TOPO, METRO-TOPO and CONV-DTX+METRO-TOPO reduced stemness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TRO-TOPO reduced CD44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to a greater extent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ared to CONV-TOPO and CONV-DTX treatments, whereas combination treatment with CONV-DTX+METRO-TOPO reduced stemness (CD44+ cells) the most in AR</a:t>
            </a:r>
            <a:r>
              <a:rPr lang="en-US" sz="1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gh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CRPC/NEPC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PC-3M,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DU145 cell lines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7F9F115-7010-434C-91E6-08A732F05C38}"/>
              </a:ext>
            </a:extLst>
          </p:cNvPr>
          <p:cNvSpPr txBox="1"/>
          <p:nvPr/>
        </p:nvSpPr>
        <p:spPr>
          <a:xfrm>
            <a:off x="259108" y="1560195"/>
            <a:ext cx="194987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8A</a:t>
            </a:r>
            <a:endParaRPr lang="en-US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14E2081-ED6B-43A1-99A3-8F34AECBB7F0}"/>
              </a:ext>
            </a:extLst>
          </p:cNvPr>
          <p:cNvGrpSpPr/>
          <p:nvPr/>
        </p:nvGrpSpPr>
        <p:grpSpPr>
          <a:xfrm>
            <a:off x="1593158" y="1623401"/>
            <a:ext cx="8564767" cy="2885587"/>
            <a:chOff x="1943536" y="3819670"/>
            <a:chExt cx="8564767" cy="2885587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07C29B34-57E2-40B4-BAA6-3BD4E2FE502C}"/>
                </a:ext>
              </a:extLst>
            </p:cNvPr>
            <p:cNvGrpSpPr/>
            <p:nvPr/>
          </p:nvGrpSpPr>
          <p:grpSpPr>
            <a:xfrm>
              <a:off x="2066647" y="4077957"/>
              <a:ext cx="8058705" cy="2627300"/>
              <a:chOff x="2066647" y="3864839"/>
              <a:chExt cx="8058705" cy="2627300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885DD820-9E85-4DAA-9944-1AED806B966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7273" b="4065"/>
              <a:stretch/>
            </p:blipFill>
            <p:spPr>
              <a:xfrm>
                <a:off x="7576495" y="3896298"/>
                <a:ext cx="2548857" cy="2595841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4FDAB96A-87A9-4D4E-AE4D-131EAB9F85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951" b="6160"/>
              <a:stretch/>
            </p:blipFill>
            <p:spPr>
              <a:xfrm>
                <a:off x="2066647" y="3864839"/>
                <a:ext cx="2512010" cy="2493759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0471EE0F-4270-4175-86B7-47BC608176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720" b="4065"/>
              <a:stretch/>
            </p:blipFill>
            <p:spPr>
              <a:xfrm>
                <a:off x="4815431" y="3896298"/>
                <a:ext cx="2536573" cy="2595841"/>
              </a:xfrm>
              <a:prstGeom prst="rect">
                <a:avLst/>
              </a:prstGeom>
            </p:spPr>
          </p:pic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18E9AB8-764D-4C13-BC8C-C4D3B1F5794D}"/>
                </a:ext>
              </a:extLst>
            </p:cNvPr>
            <p:cNvSpPr txBox="1"/>
            <p:nvPr/>
          </p:nvSpPr>
          <p:spPr>
            <a:xfrm>
              <a:off x="3348290" y="6368225"/>
              <a:ext cx="601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000E900-C0B2-4864-8E43-DD5D7648C793}"/>
                </a:ext>
              </a:extLst>
            </p:cNvPr>
            <p:cNvSpPr txBox="1"/>
            <p:nvPr/>
          </p:nvSpPr>
          <p:spPr>
            <a:xfrm>
              <a:off x="6113092" y="6448605"/>
              <a:ext cx="601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864953B-C9F4-4852-96FC-676E7E94AFA2}"/>
                </a:ext>
              </a:extLst>
            </p:cNvPr>
            <p:cNvSpPr txBox="1"/>
            <p:nvPr/>
          </p:nvSpPr>
          <p:spPr>
            <a:xfrm>
              <a:off x="8900783" y="6442196"/>
              <a:ext cx="601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89777D1-B086-4009-907E-EF8619F76225}"/>
                </a:ext>
              </a:extLst>
            </p:cNvPr>
            <p:cNvSpPr txBox="1"/>
            <p:nvPr/>
          </p:nvSpPr>
          <p:spPr>
            <a:xfrm>
              <a:off x="2346661" y="3969048"/>
              <a:ext cx="74309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-3M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7355EE8-E51B-47EA-AB64-0127C2AD6E69}"/>
                </a:ext>
              </a:extLst>
            </p:cNvPr>
            <p:cNvSpPr txBox="1"/>
            <p:nvPr/>
          </p:nvSpPr>
          <p:spPr>
            <a:xfrm>
              <a:off x="2926694" y="3964775"/>
              <a:ext cx="20069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V-TOPO (</a:t>
              </a:r>
              <a:r>
                <a:rPr kumimoji="0" lang="en-US" sz="11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38nM)</a:t>
              </a:r>
              <a:endPara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BCD7682-B2DF-42FE-9C63-C041FD9FB48C}"/>
                </a:ext>
              </a:extLst>
            </p:cNvPr>
            <p:cNvSpPr txBox="1"/>
            <p:nvPr/>
          </p:nvSpPr>
          <p:spPr>
            <a:xfrm>
              <a:off x="5710550" y="3988947"/>
              <a:ext cx="16878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TRO-TOPO (14.5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BB06353-0845-4D48-AB5B-B751EA957402}"/>
                </a:ext>
              </a:extLst>
            </p:cNvPr>
            <p:cNvSpPr txBox="1"/>
            <p:nvPr/>
          </p:nvSpPr>
          <p:spPr>
            <a:xfrm>
              <a:off x="8462014" y="3819670"/>
              <a:ext cx="2046289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V-DTX (20nM)+</a:t>
              </a:r>
            </a:p>
            <a:p>
              <a:r>
                <a:rPr lang="en-US" sz="11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TRO-TOPO (14.5nM)</a:t>
              </a:r>
            </a:p>
            <a:p>
              <a:r>
                <a:rPr lang="en-US" sz="11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B2F7736-D347-41D1-B87D-13AE6E482CBA}"/>
                </a:ext>
              </a:extLst>
            </p:cNvPr>
            <p:cNvSpPr txBox="1"/>
            <p:nvPr/>
          </p:nvSpPr>
          <p:spPr>
            <a:xfrm rot="16200000">
              <a:off x="1765695" y="5056066"/>
              <a:ext cx="601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33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99B4D6A-4447-4F5A-BDA3-28A1FB99C843}"/>
                </a:ext>
              </a:extLst>
            </p:cNvPr>
            <p:cNvSpPr txBox="1"/>
            <p:nvPr/>
          </p:nvSpPr>
          <p:spPr>
            <a:xfrm rot="16200000">
              <a:off x="4523927" y="5076859"/>
              <a:ext cx="601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33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4A5C1D8-24B7-4938-ABC7-A5B2A29C9E21}"/>
                </a:ext>
              </a:extLst>
            </p:cNvPr>
            <p:cNvSpPr txBox="1"/>
            <p:nvPr/>
          </p:nvSpPr>
          <p:spPr>
            <a:xfrm rot="16200000">
              <a:off x="7287826" y="5072754"/>
              <a:ext cx="601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33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862AE99-113A-41B5-8F82-E9ED8878015D}"/>
                </a:ext>
              </a:extLst>
            </p:cNvPr>
            <p:cNvSpPr txBox="1"/>
            <p:nvPr/>
          </p:nvSpPr>
          <p:spPr>
            <a:xfrm>
              <a:off x="5083159" y="4006039"/>
              <a:ext cx="74309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-3M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48AD268-DABD-452E-9945-1774FB89B45E}"/>
                </a:ext>
              </a:extLst>
            </p:cNvPr>
            <p:cNvSpPr txBox="1"/>
            <p:nvPr/>
          </p:nvSpPr>
          <p:spPr>
            <a:xfrm>
              <a:off x="7849735" y="4006039"/>
              <a:ext cx="74309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-3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167613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F3A70568-29E5-49FF-AEAA-8A13DFE2B399}"/>
              </a:ext>
            </a:extLst>
          </p:cNvPr>
          <p:cNvGrpSpPr/>
          <p:nvPr/>
        </p:nvGrpSpPr>
        <p:grpSpPr>
          <a:xfrm>
            <a:off x="1189126" y="2066830"/>
            <a:ext cx="9671256" cy="3156789"/>
            <a:chOff x="1336955" y="104027"/>
            <a:chExt cx="9671256" cy="3156789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D713799A-0E92-4F06-950D-C6D4306F60A7}"/>
                </a:ext>
              </a:extLst>
            </p:cNvPr>
            <p:cNvGrpSpPr/>
            <p:nvPr/>
          </p:nvGrpSpPr>
          <p:grpSpPr>
            <a:xfrm>
              <a:off x="1371796" y="104027"/>
              <a:ext cx="9636415" cy="3156789"/>
              <a:chOff x="1546788" y="3532756"/>
              <a:chExt cx="9636415" cy="3156789"/>
            </a:xfrm>
          </p:grpSpPr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34806C22-E2DF-4EA1-A9D9-493917D5D293}"/>
                  </a:ext>
                </a:extLst>
              </p:cNvPr>
              <p:cNvSpPr txBox="1"/>
              <p:nvPr/>
            </p:nvSpPr>
            <p:spPr>
              <a:xfrm>
                <a:off x="8914704" y="3532756"/>
                <a:ext cx="2268499" cy="43088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V-DTX (7nM)+</a:t>
                </a:r>
              </a:p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ETRO-TOPO (1nM)</a:t>
                </a:r>
                <a:endParaRPr kumimoji="0" lang="en-US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37F395B5-2E77-42C8-8790-99603E880837}"/>
                  </a:ext>
                </a:extLst>
              </p:cNvPr>
              <p:cNvGrpSpPr/>
              <p:nvPr/>
            </p:nvGrpSpPr>
            <p:grpSpPr>
              <a:xfrm>
                <a:off x="1546788" y="3693488"/>
                <a:ext cx="8891916" cy="2996057"/>
                <a:chOff x="1546788" y="3693488"/>
                <a:chExt cx="8891916" cy="2996057"/>
              </a:xfrm>
            </p:grpSpPr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1A78BCD1-1E42-46BB-BD5E-D18B97E05066}"/>
                    </a:ext>
                  </a:extLst>
                </p:cNvPr>
                <p:cNvGrpSpPr/>
                <p:nvPr/>
              </p:nvGrpSpPr>
              <p:grpSpPr>
                <a:xfrm>
                  <a:off x="1546788" y="3706804"/>
                  <a:ext cx="8891916" cy="2924733"/>
                  <a:chOff x="312151" y="653819"/>
                  <a:chExt cx="8891916" cy="2924733"/>
                </a:xfrm>
              </p:grpSpPr>
              <p:pic>
                <p:nvPicPr>
                  <p:cNvPr id="22" name="Picture 21">
                    <a:extLst>
                      <a:ext uri="{FF2B5EF4-FFF2-40B4-BE49-F238E27FC236}">
                        <a16:creationId xmlns:a16="http://schemas.microsoft.com/office/drawing/2014/main" id="{6DCF46D1-8D4D-4425-850D-0DB4B4E3586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8270" b="6409"/>
                  <a:stretch/>
                </p:blipFill>
                <p:spPr>
                  <a:xfrm>
                    <a:off x="312151" y="770458"/>
                    <a:ext cx="2795915" cy="2808094"/>
                  </a:xfrm>
                  <a:prstGeom prst="rect">
                    <a:avLst/>
                  </a:prstGeom>
                </p:spPr>
              </p:pic>
              <p:pic>
                <p:nvPicPr>
                  <p:cNvPr id="23" name="Picture 22">
                    <a:extLst>
                      <a:ext uri="{FF2B5EF4-FFF2-40B4-BE49-F238E27FC236}">
                        <a16:creationId xmlns:a16="http://schemas.microsoft.com/office/drawing/2014/main" id="{C46702DE-42DC-4F82-B83B-F041B7A2428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8270" b="6409"/>
                  <a:stretch/>
                </p:blipFill>
                <p:spPr>
                  <a:xfrm>
                    <a:off x="3360151" y="770458"/>
                    <a:ext cx="2795915" cy="2808094"/>
                  </a:xfrm>
                  <a:prstGeom prst="rect">
                    <a:avLst/>
                  </a:prstGeom>
                </p:spPr>
              </p:pic>
              <p:pic>
                <p:nvPicPr>
                  <p:cNvPr id="24" name="Picture 23">
                    <a:extLst>
                      <a:ext uri="{FF2B5EF4-FFF2-40B4-BE49-F238E27FC236}">
                        <a16:creationId xmlns:a16="http://schemas.microsoft.com/office/drawing/2014/main" id="{BDAB753F-ACEA-499D-9663-BDB5C21C35A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/>
                  <a:srcRect l="8270" b="6409"/>
                  <a:stretch/>
                </p:blipFill>
                <p:spPr>
                  <a:xfrm>
                    <a:off x="6408151" y="770457"/>
                    <a:ext cx="2795916" cy="2808095"/>
                  </a:xfrm>
                  <a:prstGeom prst="rect">
                    <a:avLst/>
                  </a:prstGeom>
                </p:spPr>
              </p:pic>
              <p:sp>
                <p:nvSpPr>
                  <p:cNvPr id="25" name="TextBox 24">
                    <a:extLst>
                      <a:ext uri="{FF2B5EF4-FFF2-40B4-BE49-F238E27FC236}">
                        <a16:creationId xmlns:a16="http://schemas.microsoft.com/office/drawing/2014/main" id="{7BF35B88-AB97-4C70-989D-909EA1DDC4A4}"/>
                      </a:ext>
                    </a:extLst>
                  </p:cNvPr>
                  <p:cNvSpPr txBox="1"/>
                  <p:nvPr/>
                </p:nvSpPr>
                <p:spPr>
                  <a:xfrm>
                    <a:off x="588505" y="653819"/>
                    <a:ext cx="67112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U145</a:t>
                    </a:r>
                  </a:p>
                </p:txBody>
              </p:sp>
            </p:grp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0E0E339B-3DE2-44FB-9527-231D49CD1D6B}"/>
                    </a:ext>
                  </a:extLst>
                </p:cNvPr>
                <p:cNvSpPr txBox="1"/>
                <p:nvPr/>
              </p:nvSpPr>
              <p:spPr>
                <a:xfrm>
                  <a:off x="3013113" y="6443324"/>
                  <a:ext cx="601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D44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380E1E7A-2617-4D7B-94C9-EAE61D2925E8}"/>
                    </a:ext>
                  </a:extLst>
                </p:cNvPr>
                <p:cNvSpPr txBox="1"/>
                <p:nvPr/>
              </p:nvSpPr>
              <p:spPr>
                <a:xfrm>
                  <a:off x="6055637" y="6443324"/>
                  <a:ext cx="601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D44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67838853-1A47-4CB0-B881-0E69F01BA4DB}"/>
                    </a:ext>
                  </a:extLst>
                </p:cNvPr>
                <p:cNvSpPr txBox="1"/>
                <p:nvPr/>
              </p:nvSpPr>
              <p:spPr>
                <a:xfrm>
                  <a:off x="9098161" y="6443323"/>
                  <a:ext cx="601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D44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C9DEC10A-BC08-4E5B-AC8B-CADEA59EF18B}"/>
                    </a:ext>
                  </a:extLst>
                </p:cNvPr>
                <p:cNvSpPr txBox="1"/>
                <p:nvPr/>
              </p:nvSpPr>
              <p:spPr>
                <a:xfrm>
                  <a:off x="2494262" y="3702034"/>
                  <a:ext cx="169691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NV-TOPO (3.5nM)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9F541229-560E-4A3F-BC62-869DAE688446}"/>
                    </a:ext>
                  </a:extLst>
                </p:cNvPr>
                <p:cNvSpPr txBox="1"/>
                <p:nvPr/>
              </p:nvSpPr>
              <p:spPr>
                <a:xfrm>
                  <a:off x="5498668" y="3702033"/>
                  <a:ext cx="169691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ETRO-TOPO (1nM)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9652CD02-DAE6-412C-9CDE-A40989BFBBBC}"/>
                    </a:ext>
                  </a:extLst>
                </p:cNvPr>
                <p:cNvSpPr txBox="1"/>
                <p:nvPr/>
              </p:nvSpPr>
              <p:spPr>
                <a:xfrm>
                  <a:off x="4862297" y="3693488"/>
                  <a:ext cx="67112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U145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91768887-6E10-4313-8AAD-59E8AB4CD58B}"/>
                    </a:ext>
                  </a:extLst>
                </p:cNvPr>
                <p:cNvSpPr txBox="1"/>
                <p:nvPr/>
              </p:nvSpPr>
              <p:spPr>
                <a:xfrm>
                  <a:off x="7910297" y="3706355"/>
                  <a:ext cx="67112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U145</a:t>
                  </a:r>
                </a:p>
              </p:txBody>
            </p:sp>
          </p:grpSp>
        </p:grp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FB7842D-AE41-4959-8103-6724F1192DF1}"/>
                </a:ext>
              </a:extLst>
            </p:cNvPr>
            <p:cNvSpPr txBox="1"/>
            <p:nvPr/>
          </p:nvSpPr>
          <p:spPr>
            <a:xfrm rot="16200000">
              <a:off x="7232512" y="1675648"/>
              <a:ext cx="601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33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3D762D2-5B63-4F19-9221-1808D582775D}"/>
                </a:ext>
              </a:extLst>
            </p:cNvPr>
            <p:cNvSpPr txBox="1"/>
            <p:nvPr/>
          </p:nvSpPr>
          <p:spPr>
            <a:xfrm rot="16200000">
              <a:off x="1159114" y="1675649"/>
              <a:ext cx="601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33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3994517-738D-453C-B3C9-E379D8567D49}"/>
                </a:ext>
              </a:extLst>
            </p:cNvPr>
            <p:cNvSpPr txBox="1"/>
            <p:nvPr/>
          </p:nvSpPr>
          <p:spPr>
            <a:xfrm rot="16200000">
              <a:off x="4115898" y="1675649"/>
              <a:ext cx="601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33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8D466B77-1A68-D9DE-F268-8DC35802C494}"/>
              </a:ext>
            </a:extLst>
          </p:cNvPr>
          <p:cNvSpPr txBox="1"/>
          <p:nvPr/>
        </p:nvSpPr>
        <p:spPr>
          <a:xfrm>
            <a:off x="333831" y="1936142"/>
            <a:ext cx="194987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8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4705255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7</TotalTime>
  <Words>159</Words>
  <Application>Microsoft Office PowerPoint</Application>
  <PresentationFormat>Widescreen</PresentationFormat>
  <Paragraphs>3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2_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swi Mitra Ghosh</dc:creator>
  <cp:lastModifiedBy>AMIT MITRA</cp:lastModifiedBy>
  <cp:revision>114</cp:revision>
  <cp:lastPrinted>2022-04-06T04:19:54Z</cp:lastPrinted>
  <dcterms:created xsi:type="dcterms:W3CDTF">2021-11-23T16:14:52Z</dcterms:created>
  <dcterms:modified xsi:type="dcterms:W3CDTF">2023-05-31T16:11:36Z</dcterms:modified>
</cp:coreProperties>
</file>